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3" r:id="rId3"/>
    <p:sldId id="321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F3D11"/>
    <a:srgbClr val="C75629"/>
    <a:srgbClr val="AD5A43"/>
    <a:srgbClr val="B87238"/>
    <a:srgbClr val="E2D9D6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42" autoAdjust="0"/>
  </p:normalViewPr>
  <p:slideViewPr>
    <p:cSldViewPr>
      <p:cViewPr varScale="1">
        <p:scale>
          <a:sx n="108" d="100"/>
          <a:sy n="108" d="100"/>
        </p:scale>
        <p:origin x="170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C3EE7A-2235-4B10-80B2-A4092DA64631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818EDB-B0A3-4FBE-9032-A6531E2E1E2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zh-CN" dirty="0" smtClean="0"/>
              <a:t>103  157 334  176  487  546  59  75 268  217 80  61    mRNA and sRNA 1689  fold change</a:t>
            </a:r>
            <a:r>
              <a:rPr lang="zh-CN" altLang="en-US" baseline="0" dirty="0" smtClean="0"/>
              <a:t> </a:t>
            </a:r>
            <a:r>
              <a:rPr lang="en-US" altLang="zh-CN" baseline="0" dirty="0" smtClean="0"/>
              <a:t>2.0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818EDB-B0A3-4FBE-9032-A6531E2E1E25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altLang="zh-CN" dirty="0" smtClean="0"/>
              <a:t>mRNA</a:t>
            </a:r>
          </a:p>
          <a:p>
            <a:r>
              <a:rPr lang="en-US" altLang="zh-CN" dirty="0" smtClean="0"/>
              <a:t>P- adjust 0.001  2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7818EDB-B0A3-4FBE-9032-A6531E2E1E25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5/5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Relationship Id="rId9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 cstate="print"/>
          <a:srcRect t="10685" r="15881" b="11846"/>
          <a:stretch>
            <a:fillRect/>
          </a:stretch>
        </p:blipFill>
        <p:spPr bwMode="auto">
          <a:xfrm>
            <a:off x="107506" y="703729"/>
            <a:ext cx="3001988" cy="22322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/>
          <p:cNvSpPr txBox="1"/>
          <p:nvPr/>
        </p:nvSpPr>
        <p:spPr>
          <a:xfrm>
            <a:off x="467544" y="2863969"/>
            <a:ext cx="25922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Man    LAra      Gal      Glu      Xyl        Fru</a:t>
            </a:r>
            <a:endParaRPr lang="zh-CN" altLang="en-US" sz="1200" dirty="0"/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5496" y="3429000"/>
            <a:ext cx="2796005" cy="2736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5" cstate="print"/>
          <a:srcRect t="8387" r="15894" b="12540"/>
          <a:stretch>
            <a:fillRect/>
          </a:stretch>
        </p:blipFill>
        <p:spPr bwMode="auto">
          <a:xfrm>
            <a:off x="3059832" y="631721"/>
            <a:ext cx="3062366" cy="23231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>
            <a:off x="3419872" y="2863969"/>
            <a:ext cx="26642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 Fru      Gal       Glu        LAra </a:t>
            </a:r>
            <a:r>
              <a:rPr lang="zh-CN" altLang="en-US" sz="1200" dirty="0" smtClean="0"/>
              <a:t>    </a:t>
            </a:r>
            <a:r>
              <a:rPr lang="en-US" altLang="zh-CN" sz="1200" dirty="0" smtClean="0"/>
              <a:t>Man    Xyl </a:t>
            </a:r>
            <a:endParaRPr lang="zh-CN" altLang="en-US" sz="1200" dirty="0"/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2843808" y="3356992"/>
            <a:ext cx="3031312" cy="2736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" name="Picture 2"/>
          <p:cNvPicPr>
            <a:picLocks noChangeAspect="1" noChangeArrowheads="1"/>
          </p:cNvPicPr>
          <p:nvPr/>
        </p:nvPicPr>
        <p:blipFill>
          <a:blip r:embed="rId7" cstate="print"/>
          <a:srcRect t="9866" r="16428" b="8739"/>
          <a:stretch>
            <a:fillRect/>
          </a:stretch>
        </p:blipFill>
        <p:spPr bwMode="auto">
          <a:xfrm>
            <a:off x="6047749" y="611249"/>
            <a:ext cx="3096251" cy="234888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4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6156176" y="3501008"/>
            <a:ext cx="2749211" cy="27363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4" name="TextBox 13"/>
          <p:cNvSpPr txBox="1"/>
          <p:nvPr/>
        </p:nvSpPr>
        <p:spPr>
          <a:xfrm>
            <a:off x="107504" y="32336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3203848" y="32336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107504" y="321297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D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3347864" y="3212976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E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6156176" y="32336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6369768" y="3212976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6407032" y="2863969"/>
            <a:ext cx="26642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/>
              <a:t> Fru      Gal       Glu        LAra </a:t>
            </a:r>
            <a:r>
              <a:rPr lang="zh-CN" altLang="en-US" sz="1200" dirty="0" smtClean="0"/>
              <a:t>    </a:t>
            </a:r>
            <a:r>
              <a:rPr lang="en-US" altLang="zh-CN" sz="1200" dirty="0" smtClean="0"/>
              <a:t>Man    Xyl </a:t>
            </a:r>
            <a:endParaRPr lang="zh-CN" alt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 t="10638"/>
          <a:stretch>
            <a:fillRect/>
          </a:stretch>
        </p:blipFill>
        <p:spPr bwMode="auto">
          <a:xfrm>
            <a:off x="6163520" y="3501008"/>
            <a:ext cx="2945160" cy="2952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4" cstate="print"/>
          <a:srcRect t="10638"/>
          <a:stretch>
            <a:fillRect/>
          </a:stretch>
        </p:blipFill>
        <p:spPr bwMode="auto">
          <a:xfrm>
            <a:off x="3133616" y="3573016"/>
            <a:ext cx="2950594" cy="2952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9" name="Picture 2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228186" y="332656"/>
            <a:ext cx="2534896" cy="2808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79512" y="188640"/>
            <a:ext cx="2598498" cy="28803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7" cstate="print"/>
          <a:srcRect t="10680"/>
          <a:stretch>
            <a:fillRect/>
          </a:stretch>
        </p:blipFill>
        <p:spPr bwMode="auto">
          <a:xfrm>
            <a:off x="107505" y="3586311"/>
            <a:ext cx="2962510" cy="2939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2"/>
          <p:cNvPicPr>
            <a:picLocks noChangeAspect="1" noChangeArrowheads="1"/>
          </p:cNvPicPr>
          <p:nvPr/>
        </p:nvPicPr>
        <p:blipFill>
          <a:blip r:embed="rId8" cstate="print"/>
          <a:srcRect t="10960"/>
          <a:stretch>
            <a:fillRect/>
          </a:stretch>
        </p:blipFill>
        <p:spPr bwMode="auto">
          <a:xfrm>
            <a:off x="3131840" y="188640"/>
            <a:ext cx="2968490" cy="29249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TextBox 16"/>
          <p:cNvSpPr txBox="1"/>
          <p:nvPr/>
        </p:nvSpPr>
        <p:spPr>
          <a:xfrm>
            <a:off x="-36512" y="-3667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2915816" y="44624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-36512" y="3356992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D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3131840" y="3284984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E</a:t>
            </a:r>
            <a:endParaRPr lang="zh-CN" alt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6084168" y="44624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  <p:sp>
        <p:nvSpPr>
          <p:cNvPr id="22" name="TextBox 21"/>
          <p:cNvSpPr txBox="1"/>
          <p:nvPr/>
        </p:nvSpPr>
        <p:spPr>
          <a:xfrm>
            <a:off x="6084168" y="3284984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F</a:t>
            </a:r>
            <a:endParaRPr lang="zh-CN" altLang="en-US" dirty="0"/>
          </a:p>
        </p:txBody>
      </p:sp>
      <p:sp>
        <p:nvSpPr>
          <p:cNvPr id="23" name="矩形 22"/>
          <p:cNvSpPr/>
          <p:nvPr/>
        </p:nvSpPr>
        <p:spPr>
          <a:xfrm>
            <a:off x="6588224" y="6417332"/>
            <a:ext cx="138255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/>
              <a:t>Suc_vs_Xyl.volcano</a:t>
            </a:r>
            <a:endParaRPr lang="zh-CN" altLang="en-US" sz="1200" dirty="0"/>
          </a:p>
        </p:txBody>
      </p:sp>
      <p:sp>
        <p:nvSpPr>
          <p:cNvPr id="24" name="矩形 23"/>
          <p:cNvSpPr/>
          <p:nvPr/>
        </p:nvSpPr>
        <p:spPr>
          <a:xfrm>
            <a:off x="3579799" y="3104964"/>
            <a:ext cx="14082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/>
              <a:t>Suc_vs_Gal.volcano</a:t>
            </a:r>
            <a:endParaRPr lang="zh-CN" altLang="en-US" sz="1200" dirty="0"/>
          </a:p>
        </p:txBody>
      </p:sp>
      <p:sp>
        <p:nvSpPr>
          <p:cNvPr id="30" name="矩形 29"/>
          <p:cNvSpPr/>
          <p:nvPr/>
        </p:nvSpPr>
        <p:spPr>
          <a:xfrm>
            <a:off x="6588224" y="3104964"/>
            <a:ext cx="141461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/>
              <a:t>Suc_vs_Glu.volcano</a:t>
            </a:r>
            <a:endParaRPr lang="zh-CN" altLang="en-US" sz="1200" dirty="0"/>
          </a:p>
        </p:txBody>
      </p:sp>
      <p:sp>
        <p:nvSpPr>
          <p:cNvPr id="31" name="矩形 30"/>
          <p:cNvSpPr/>
          <p:nvPr/>
        </p:nvSpPr>
        <p:spPr>
          <a:xfrm>
            <a:off x="502704" y="3104964"/>
            <a:ext cx="14050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/>
              <a:t>Suc_vs_Fru.volcano</a:t>
            </a:r>
            <a:endParaRPr lang="zh-CN" altLang="en-US" sz="1200" dirty="0"/>
          </a:p>
        </p:txBody>
      </p:sp>
      <p:sp>
        <p:nvSpPr>
          <p:cNvPr id="32" name="矩形 31"/>
          <p:cNvSpPr/>
          <p:nvPr/>
        </p:nvSpPr>
        <p:spPr>
          <a:xfrm>
            <a:off x="467544" y="6417332"/>
            <a:ext cx="14788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/>
              <a:t>Suc_vs_LAra.volcano</a:t>
            </a:r>
            <a:endParaRPr lang="zh-CN" altLang="en-US" sz="1200" dirty="0"/>
          </a:p>
        </p:txBody>
      </p:sp>
      <p:sp>
        <p:nvSpPr>
          <p:cNvPr id="33" name="矩形 32"/>
          <p:cNvSpPr/>
          <p:nvPr/>
        </p:nvSpPr>
        <p:spPr>
          <a:xfrm>
            <a:off x="3563888" y="6417332"/>
            <a:ext cx="14867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 smtClean="0"/>
              <a:t>Suc_vs_Man.volcano</a:t>
            </a:r>
            <a:endParaRPr lang="zh-CN" altLang="en-US" sz="1200" dirty="0"/>
          </a:p>
        </p:txBody>
      </p:sp>
      <p:sp>
        <p:nvSpPr>
          <p:cNvPr id="34" name="TextBox 33"/>
          <p:cNvSpPr txBox="1"/>
          <p:nvPr/>
        </p:nvSpPr>
        <p:spPr>
          <a:xfrm>
            <a:off x="1851607" y="3104964"/>
            <a:ext cx="632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Log2FC</a:t>
            </a:r>
            <a:endParaRPr lang="zh-CN" altLang="en-US" sz="1200" dirty="0"/>
          </a:p>
        </p:txBody>
      </p:sp>
      <p:sp>
        <p:nvSpPr>
          <p:cNvPr id="35" name="TextBox 34"/>
          <p:cNvSpPr txBox="1"/>
          <p:nvPr/>
        </p:nvSpPr>
        <p:spPr>
          <a:xfrm>
            <a:off x="2139639" y="6417332"/>
            <a:ext cx="632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Log2FC</a:t>
            </a:r>
            <a:endParaRPr lang="zh-CN" alt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7972287" y="3104964"/>
            <a:ext cx="632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Log2FC</a:t>
            </a:r>
            <a:endParaRPr lang="zh-CN" altLang="en-US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5091967" y="3104964"/>
            <a:ext cx="632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Log2FC</a:t>
            </a:r>
            <a:endParaRPr lang="zh-CN" altLang="en-US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8188311" y="6417332"/>
            <a:ext cx="632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Log2FC</a:t>
            </a:r>
            <a:endParaRPr lang="zh-CN" alt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5163975" y="6417332"/>
            <a:ext cx="632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Log2FC</a:t>
            </a:r>
            <a:endParaRPr lang="zh-CN" altLang="en-US" sz="1200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627784" y="1556792"/>
            <a:ext cx="432047" cy="3819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0" name="TextBox 39"/>
          <p:cNvSpPr txBox="1"/>
          <p:nvPr/>
        </p:nvSpPr>
        <p:spPr>
          <a:xfrm rot="16200000">
            <a:off x="-584129" y="1384330"/>
            <a:ext cx="13722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smtClean="0"/>
              <a:t>-Log10</a:t>
            </a:r>
            <a:r>
              <a:rPr lang="zh-CN" altLang="en-US" sz="1200" dirty="0" smtClean="0"/>
              <a:t>（</a:t>
            </a:r>
            <a:r>
              <a:rPr lang="en-US" altLang="zh-CN" sz="1200" dirty="0" smtClean="0"/>
              <a:t>Padjust</a:t>
            </a:r>
            <a:r>
              <a:rPr lang="zh-CN" altLang="en-US" sz="1200" dirty="0" smtClean="0"/>
              <a:t>）</a:t>
            </a:r>
            <a:endParaRPr lang="zh-CN" alt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 r="9737"/>
          <a:stretch>
            <a:fillRect/>
          </a:stretch>
        </p:blipFill>
        <p:spPr bwMode="auto">
          <a:xfrm>
            <a:off x="683568" y="764704"/>
            <a:ext cx="6814003" cy="41764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 cstate="print"/>
          <a:srcRect l="91695" t="10359" b="53385"/>
          <a:stretch>
            <a:fillRect/>
          </a:stretch>
        </p:blipFill>
        <p:spPr bwMode="auto">
          <a:xfrm>
            <a:off x="5724128" y="2204864"/>
            <a:ext cx="417385" cy="1008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21</TotalTime>
  <Words>75</Words>
  <Application>Microsoft Office PowerPoint</Application>
  <PresentationFormat>全屏显示(4:3)</PresentationFormat>
  <Paragraphs>33</Paragraphs>
  <Slides>3</Slides>
  <Notes>2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664</cp:revision>
  <dcterms:modified xsi:type="dcterms:W3CDTF">2025-05-29T03:43:26Z</dcterms:modified>
</cp:coreProperties>
</file>